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81" d="100"/>
          <a:sy n="81" d="100"/>
        </p:scale>
        <p:origin x="1440" y="-2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30576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2927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3593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09816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64711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81635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85004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8061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40266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04288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362854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CDB3E-4D17-434C-9C0C-F1E3E9CB8454}" type="datetimeFigureOut">
              <a:rPr lang="zh-CN" altLang="en-US" smtClean="0"/>
              <a:t>2023/1/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FEEEB-6D41-409B-8EEB-6CAE845E236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56338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>
            <a:extLst>
              <a:ext uri="{FF2B5EF4-FFF2-40B4-BE49-F238E27FC236}">
                <a16:creationId xmlns:a16="http://schemas.microsoft.com/office/drawing/2014/main" id="{BD1B2720-9871-4DA1-A548-AAFB29EE9DF1}"/>
              </a:ext>
            </a:extLst>
          </p:cNvPr>
          <p:cNvSpPr/>
          <p:nvPr/>
        </p:nvSpPr>
        <p:spPr>
          <a:xfrm>
            <a:off x="168446" y="8631560"/>
            <a:ext cx="6421040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tabLst>
                <a:tab pos="3483293" algn="r"/>
              </a:tabLst>
            </a:pPr>
            <a:r>
              <a:rPr lang="en-US" altLang="zh-CN" sz="1400" b="1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upplementary Fig. S1</a:t>
            </a:r>
            <a:r>
              <a:rPr lang="en-US" altLang="zh-CN" sz="1400" kern="10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Regulatory elements in pSjNR-L. Their positions relative to SjNR-L +1 start codon ATG are indicated. Vertical line points to the first base of each element.</a:t>
            </a:r>
            <a:endParaRPr lang="zh-CN" altLang="zh-CN" sz="1400" kern="100">
              <a:latin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E9964B2F-CAAD-4923-B438-0533482E13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8446" y="328089"/>
            <a:ext cx="6517189" cy="838272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1755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33</Words>
  <Application>Microsoft Office PowerPoint</Application>
  <PresentationFormat>A4 纸张(210x297 毫米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Lenovo</cp:lastModifiedBy>
  <cp:revision>7</cp:revision>
  <dcterms:created xsi:type="dcterms:W3CDTF">2023-01-05T08:55:07Z</dcterms:created>
  <dcterms:modified xsi:type="dcterms:W3CDTF">2023-01-05T21:46:12Z</dcterms:modified>
</cp:coreProperties>
</file>